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5C5132-5C7F-417A-940B-596B4B39C01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1C9CD9-B6E3-42E1-BB09-54184D81DDA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C87CD3-45B5-401D-AEC2-B68CACB6246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13EAE4-9AA6-4727-976A-19E6A71BC26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06CE1F-AC26-4EA9-A5AF-D3FF7F75A0C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08236E-3005-4BE8-A99D-8D39822FE51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F7412B-47CC-4853-A59B-7E6EE4AB594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266212-4B3D-4C7E-BA33-9E25BFB9740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FA7861-5D45-4AFE-B597-78917B33824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DED9B3-0174-42EB-87EF-35C79D7F9D5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64245A-5AFB-42BD-87EA-F555502A190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1B3E76-C610-4848-A74C-C6918717E23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54D1A6A-50B6-48D3-AB70-B34929F37F1D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3"/>
          <p:cNvSpPr/>
          <p:nvPr/>
        </p:nvSpPr>
        <p:spPr>
          <a:xfrm>
            <a:off x="513360" y="399960"/>
            <a:ext cx="5426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Supplementary FIG 3: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SMT-738 concentration-time profiles in plasma after IV infusion administration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4" descr=""/>
          <p:cNvPicPr/>
          <p:nvPr/>
        </p:nvPicPr>
        <p:blipFill>
          <a:blip r:embed="rId1"/>
          <a:stretch/>
        </p:blipFill>
        <p:spPr>
          <a:xfrm>
            <a:off x="2700360" y="1968480"/>
            <a:ext cx="4029120" cy="2703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3-09-18T20:32:20Z</dcterms:created>
  <dc:creator>Chien-Ming Li</dc:creator>
  <dc:description/>
  <dc:language>en-US</dc:language>
  <cp:lastModifiedBy>Chien-Ming Li</cp:lastModifiedBy>
  <dcterms:modified xsi:type="dcterms:W3CDTF">2023-11-07T21:47:17Z</dcterms:modified>
  <cp:revision>4</cp:revision>
  <dc:subject/>
  <dc:title>PowerPoint Presentation</dc:title>
</cp:coreProperties>
</file>